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 varScale="1">
        <p:scale>
          <a:sx n="46" d="100"/>
          <a:sy n="46" d="100"/>
        </p:scale>
        <p:origin x="2262" y="54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8128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4533CFAE-660B-01A8-70B3-E3A367D761C3}"/>
              </a:ext>
            </a:extLst>
          </p:cNvPr>
          <p:cNvSpPr txBox="1"/>
          <p:nvPr/>
        </p:nvSpPr>
        <p:spPr>
          <a:xfrm>
            <a:off x="549360" y="3030237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2 | Distribution of the best chemotype markers between chemotypes.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Upset plot of the top 50 markers for each chemotype from LC-MS modelling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e absence of a dot means that the features involved in this variable intersection were not detected in the corresponding chemotype.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Keto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artemisia ketone chemotype,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BThu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 chemotype,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BThu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α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/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 chemotype,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acet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artemisyl acetate/artemisia ketone/artemisia alcohol chemotype,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yrox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(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Z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)-myroxide/santolina triene/artemisyl acetate chemotype.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E8D03B5-A10D-B3C7-099D-4EA7287B3A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749" y="437970"/>
            <a:ext cx="2880000" cy="2493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71505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7</TotalTime>
  <Words>97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 Light</vt:lpstr>
      <vt:lpstr>Calibri</vt:lpstr>
      <vt:lpstr>Arial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0</cp:revision>
  <dcterms:created xsi:type="dcterms:W3CDTF">2020-07-29T08:33:47Z</dcterms:created>
  <dcterms:modified xsi:type="dcterms:W3CDTF">2023-02-15T14:10:16Z</dcterms:modified>
</cp:coreProperties>
</file>